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16F78-BF17-4214-AABE-4BE61B83C7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A481C-88F6-46D9-B691-1DE9812C22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53FE9-1C6E-4A75-A351-2966E233FB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E08AD-9CDB-44DF-B1A7-5D49511B7C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43BA8-0560-476B-B7C1-6712BD5FCE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E4153-5009-4DEA-A67A-BFF90FCA2F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CD170-D01A-4111-BEFB-09ACBB6291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E4954-A327-4264-AB24-78A7D7494A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A6B265-41B9-482E-BA23-F5CD2AE31B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F95BB-BE21-4259-B617-13808A9198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08D72-7776-4A7B-94F0-1AF06917F7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78481-EAE4-40EB-BBC6-E7999F55A7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8191B3-68BC-4531-A432-AB69EA7236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47640" y="4005360"/>
            <a:ext cx="71406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NFQKVEKIGEGTYGVVYKARNKLTGEVVALKKIRLDTETEGVPSTAIREISLLKELNHPNIVKLLDVIHTENKLYLVFEFLHQDLKKFMDASALTGIPLPLIKSYLFQLLQGLAFCHSHRVLHRDLKPQNLLINTEGAIKLADFGLARAFGVPVRTYTHEVVTLWYRAPEILLGCKYYSTAVDIWSLGCIFAEMVTRRALFPGDSEIDQLFRIFRTLGTPDEVVWPGVTSMPDYKPSFPKWARQDFSKVVPPLDEDGRSLLSQMLHYDPNKRISAKAALAHPFFQDVTKPVPHLRL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GFQTV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RMLALWSRRPRSPAFDARRKQLRIKNNSLFIRYITAL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11280" y="4005360"/>
            <a:ext cx="8146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CDK2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ff0000"/>
                </a:solidFill>
                <a:latin typeface="Arial"/>
              </a:rPr>
              <a:t>p27 Tai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547640" y="1125360"/>
            <a:ext cx="7054920" cy="222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TG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AGAACTTCCAAAAGGTGGAAAAGATCGGAGAGGGCACGTACGGAGTTGTGTACAAAGCCAGAAACAAGTTGACGGGAGAGGTGGTGGCGCTTAAGAAAATCCGCCTGGACACTGAGACTGAGGGTGTGCCCAGTACTGCCATCCGAGAGATCTCTCTGCTTAAGGAGCTTAACCATCCTAATATTGTCAAGCTGCTGGATGTCATTCACACAGAAAATAAACTCTACCTGGTTTTTGAATTTCTGCACCAAGATCTCAAGAAATTCATGGATGCCTCTGCTCTCACTGGCATTCCTCTTCCCCTCATCAAGAGCTATCTGTTCCAGCTGCTCCAGGGCCTAGCTTTCTGCCATTCTCATCGGGTCCTCCACCGAGACCTTAAACCTCAGAATCTGCTTATTAACACAGAGGGGGCCATCAAGCTAGCAGACTTTGGACTAGCCAGAGCTTTTGGAGTCCCTGTTCGTACTTACACCCATGAGGTGGTGACCCTGTGGTACCGAGCTCCTGAAATCCTCCTGGGCTGCAAATATTATTCCACAGCTGTGGACATCTGGAGCCTGGGCTGCATCTTTGCTGAGATGGTGACTCGCCGGGCCCTATTCCCTGGAGATTCTGAGATTGACCAGCTCTTCCGGATCTTTCGGACTCTGGGGACCCCAGATGAGGTGGTGTGGCCAGGAGTTACTTCTATGCCTGATTACAAGCCAAGTTTCCCCAAGTGGGCCCGGCAAGATTTTAGTAAAGTTGTACCTCCCCTGGATGAAGATGGACGGAGCTTGTTATCGCAAATGCTGCACTACGACCCTAACAAGCGGATTTCGGCCAAGGCAGCCCTGGCTCACCCTTTCTTCCAGGATGTGACCAAGCCAGTACCCCATCTTCGACTCGGA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TTTCAGACGGTTCCCCGAATGCTGGCACTGTGGAGCAGACGCCCAAGAAGCCCGGCCTTCGACGCCAGACGTAAACAGCTCCGAATTAAGAATAATTCCTTGTTTATTAGATACATCACTGCTTTATGA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11280" y="1692360"/>
            <a:ext cx="8146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CDK2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ff0000"/>
                </a:solidFill>
                <a:latin typeface="Arial"/>
              </a:rPr>
              <a:t>p27 Tai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558320" y="798480"/>
            <a:ext cx="66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460040" y="3614760"/>
            <a:ext cx="90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37960" y="85680"/>
            <a:ext cx="145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8T10:36:14Z</dcterms:created>
  <dc:creator>natalia.pellegata</dc:creator>
  <dc:description/>
  <dc:language>en-US</dc:language>
  <cp:lastModifiedBy>natalia.pellegata</cp:lastModifiedBy>
  <dcterms:modified xsi:type="dcterms:W3CDTF">2010-05-18T10:36:20Z</dcterms:modified>
  <cp:revision>1</cp:revision>
  <dc:subject/>
  <dc:title>Slide 1</dc:title>
</cp:coreProperties>
</file>